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5588" cy="12961938"/>
  <p:notesSz cx="6858000" cy="9144000"/>
  <p:defaultTextStyle>
    <a:defPPr>
      <a:defRPr lang="zh-CN"/>
    </a:defPPr>
    <a:lvl1pPr marL="0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1pPr>
    <a:lvl2pPr marL="785881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2pPr>
    <a:lvl3pPr marL="1571762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3pPr>
    <a:lvl4pPr marL="2357643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4pPr>
    <a:lvl5pPr marL="3143524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5pPr>
    <a:lvl6pPr marL="3929405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6pPr>
    <a:lvl7pPr marL="4715286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7pPr>
    <a:lvl8pPr marL="5501168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8pPr>
    <a:lvl9pPr marL="6287049" algn="l" defTabSz="1571762" rtl="0" eaLnBrk="1" latinLnBrk="0" hangingPunct="1">
      <a:defRPr sz="3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72" y="-72"/>
      </p:cViewPr>
      <p:guideLst>
        <p:guide orient="horz" pos="4083"/>
        <p:guide pos="28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CF9D9E-7432-4E42-9F85-6382C0C331DD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19325" y="685800"/>
            <a:ext cx="24193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9D4CD8-7EB5-4BEA-84CD-0F6A04C163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27166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785881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571762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2357643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3143524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3929405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4715286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5501168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6287049" algn="l" defTabSz="15717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19325" y="685800"/>
            <a:ext cx="24193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9D4CD8-7EB5-4BEA-84CD-0F6A04C163B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95800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919" y="4026610"/>
            <a:ext cx="7773750" cy="277841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838" y="7345100"/>
            <a:ext cx="6401912" cy="33124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858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717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576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1435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9294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7152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5011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2870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30561" y="519087"/>
            <a:ext cx="2057757" cy="1105965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89" y="519087"/>
            <a:ext cx="6020845" cy="1105965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439" y="8329250"/>
            <a:ext cx="7773750" cy="2574386"/>
          </a:xfrm>
        </p:spPr>
        <p:txBody>
          <a:bodyPr anchor="t"/>
          <a:lstStyle>
            <a:lvl1pPr algn="l">
              <a:defRPr sz="69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439" y="5493830"/>
            <a:ext cx="7773750" cy="2835420"/>
          </a:xfrm>
        </p:spPr>
        <p:txBody>
          <a:bodyPr anchor="b"/>
          <a:lstStyle>
            <a:lvl1pPr marL="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1pPr>
            <a:lvl2pPr marL="785881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2pPr>
            <a:lvl3pPr marL="1571762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3pPr>
            <a:lvl4pPr marL="235764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143524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92940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71528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501168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287049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81" y="3024459"/>
            <a:ext cx="4039301" cy="8554281"/>
          </a:xfrm>
        </p:spPr>
        <p:txBody>
          <a:bodyPr/>
          <a:lstStyle>
            <a:lvl1pPr>
              <a:defRPr sz="4800"/>
            </a:lvl1pPr>
            <a:lvl2pPr>
              <a:defRPr sz="41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9013" y="3024459"/>
            <a:ext cx="4039301" cy="8554281"/>
          </a:xfrm>
        </p:spPr>
        <p:txBody>
          <a:bodyPr/>
          <a:lstStyle>
            <a:lvl1pPr>
              <a:defRPr sz="4800"/>
            </a:lvl1pPr>
            <a:lvl2pPr>
              <a:defRPr sz="41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80" y="2901438"/>
            <a:ext cx="4040890" cy="1209180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85881" indent="0">
              <a:buNone/>
              <a:defRPr sz="3400" b="1"/>
            </a:lvl2pPr>
            <a:lvl3pPr marL="1571762" indent="0">
              <a:buNone/>
              <a:defRPr sz="3100" b="1"/>
            </a:lvl3pPr>
            <a:lvl4pPr marL="2357643" indent="0">
              <a:buNone/>
              <a:defRPr sz="2800" b="1"/>
            </a:lvl4pPr>
            <a:lvl5pPr marL="3143524" indent="0">
              <a:buNone/>
              <a:defRPr sz="2800" b="1"/>
            </a:lvl5pPr>
            <a:lvl6pPr marL="3929405" indent="0">
              <a:buNone/>
              <a:defRPr sz="2800" b="1"/>
            </a:lvl6pPr>
            <a:lvl7pPr marL="4715286" indent="0">
              <a:buNone/>
              <a:defRPr sz="2800" b="1"/>
            </a:lvl7pPr>
            <a:lvl8pPr marL="5501168" indent="0">
              <a:buNone/>
              <a:defRPr sz="2800" b="1"/>
            </a:lvl8pPr>
            <a:lvl9pPr marL="6287049" indent="0">
              <a:buNone/>
              <a:defRPr sz="28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80" y="4110619"/>
            <a:ext cx="4040890" cy="7468118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842" y="2901438"/>
            <a:ext cx="4042477" cy="1209180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85881" indent="0">
              <a:buNone/>
              <a:defRPr sz="3400" b="1"/>
            </a:lvl2pPr>
            <a:lvl3pPr marL="1571762" indent="0">
              <a:buNone/>
              <a:defRPr sz="3100" b="1"/>
            </a:lvl3pPr>
            <a:lvl4pPr marL="2357643" indent="0">
              <a:buNone/>
              <a:defRPr sz="2800" b="1"/>
            </a:lvl4pPr>
            <a:lvl5pPr marL="3143524" indent="0">
              <a:buNone/>
              <a:defRPr sz="2800" b="1"/>
            </a:lvl5pPr>
            <a:lvl6pPr marL="3929405" indent="0">
              <a:buNone/>
              <a:defRPr sz="2800" b="1"/>
            </a:lvl6pPr>
            <a:lvl7pPr marL="4715286" indent="0">
              <a:buNone/>
              <a:defRPr sz="2800" b="1"/>
            </a:lvl7pPr>
            <a:lvl8pPr marL="5501168" indent="0">
              <a:buNone/>
              <a:defRPr sz="2800" b="1"/>
            </a:lvl8pPr>
            <a:lvl9pPr marL="6287049" indent="0">
              <a:buNone/>
              <a:defRPr sz="28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842" y="4110619"/>
            <a:ext cx="4042477" cy="7468118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81" y="516084"/>
            <a:ext cx="3008836" cy="2196330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671" y="516083"/>
            <a:ext cx="5112638" cy="11062657"/>
          </a:xfrm>
        </p:spPr>
        <p:txBody>
          <a:bodyPr/>
          <a:lstStyle>
            <a:lvl1pPr>
              <a:defRPr sz="5500"/>
            </a:lvl1pPr>
            <a:lvl2pPr>
              <a:defRPr sz="4800"/>
            </a:lvl2pPr>
            <a:lvl3pPr>
              <a:defRPr sz="41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81" y="2712415"/>
            <a:ext cx="3008836" cy="8866325"/>
          </a:xfrm>
        </p:spPr>
        <p:txBody>
          <a:bodyPr/>
          <a:lstStyle>
            <a:lvl1pPr marL="0" indent="0">
              <a:buNone/>
              <a:defRPr sz="2400"/>
            </a:lvl1pPr>
            <a:lvl2pPr marL="785881" indent="0">
              <a:buNone/>
              <a:defRPr sz="2100"/>
            </a:lvl2pPr>
            <a:lvl3pPr marL="1571762" indent="0">
              <a:buNone/>
              <a:defRPr sz="1700"/>
            </a:lvl3pPr>
            <a:lvl4pPr marL="2357643" indent="0">
              <a:buNone/>
              <a:defRPr sz="1500"/>
            </a:lvl4pPr>
            <a:lvl5pPr marL="3143524" indent="0">
              <a:buNone/>
              <a:defRPr sz="1500"/>
            </a:lvl5pPr>
            <a:lvl6pPr marL="3929405" indent="0">
              <a:buNone/>
              <a:defRPr sz="1500"/>
            </a:lvl6pPr>
            <a:lvl7pPr marL="4715286" indent="0">
              <a:buNone/>
              <a:defRPr sz="1500"/>
            </a:lvl7pPr>
            <a:lvl8pPr marL="5501168" indent="0">
              <a:buNone/>
              <a:defRPr sz="1500"/>
            </a:lvl8pPr>
            <a:lvl9pPr marL="6287049" indent="0">
              <a:buNone/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609" y="9073363"/>
            <a:ext cx="5487353" cy="1071162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609" y="1158174"/>
            <a:ext cx="5487353" cy="7777163"/>
          </a:xfrm>
        </p:spPr>
        <p:txBody>
          <a:bodyPr/>
          <a:lstStyle>
            <a:lvl1pPr marL="0" indent="0">
              <a:buNone/>
              <a:defRPr sz="5500"/>
            </a:lvl1pPr>
            <a:lvl2pPr marL="785881" indent="0">
              <a:buNone/>
              <a:defRPr sz="4800"/>
            </a:lvl2pPr>
            <a:lvl3pPr marL="1571762" indent="0">
              <a:buNone/>
              <a:defRPr sz="4100"/>
            </a:lvl3pPr>
            <a:lvl4pPr marL="2357643" indent="0">
              <a:buNone/>
              <a:defRPr sz="3400"/>
            </a:lvl4pPr>
            <a:lvl5pPr marL="3143524" indent="0">
              <a:buNone/>
              <a:defRPr sz="3400"/>
            </a:lvl5pPr>
            <a:lvl6pPr marL="3929405" indent="0">
              <a:buNone/>
              <a:defRPr sz="3400"/>
            </a:lvl6pPr>
            <a:lvl7pPr marL="4715286" indent="0">
              <a:buNone/>
              <a:defRPr sz="3400"/>
            </a:lvl7pPr>
            <a:lvl8pPr marL="5501168" indent="0">
              <a:buNone/>
              <a:defRPr sz="3400"/>
            </a:lvl8pPr>
            <a:lvl9pPr marL="6287049" indent="0">
              <a:buNone/>
              <a:defRPr sz="34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609" y="10144524"/>
            <a:ext cx="5487353" cy="1521227"/>
          </a:xfrm>
        </p:spPr>
        <p:txBody>
          <a:bodyPr/>
          <a:lstStyle>
            <a:lvl1pPr marL="0" indent="0">
              <a:buNone/>
              <a:defRPr sz="2400"/>
            </a:lvl1pPr>
            <a:lvl2pPr marL="785881" indent="0">
              <a:buNone/>
              <a:defRPr sz="2100"/>
            </a:lvl2pPr>
            <a:lvl3pPr marL="1571762" indent="0">
              <a:buNone/>
              <a:defRPr sz="1700"/>
            </a:lvl3pPr>
            <a:lvl4pPr marL="2357643" indent="0">
              <a:buNone/>
              <a:defRPr sz="1500"/>
            </a:lvl4pPr>
            <a:lvl5pPr marL="3143524" indent="0">
              <a:buNone/>
              <a:defRPr sz="1500"/>
            </a:lvl5pPr>
            <a:lvl6pPr marL="3929405" indent="0">
              <a:buNone/>
              <a:defRPr sz="1500"/>
            </a:lvl6pPr>
            <a:lvl7pPr marL="4715286" indent="0">
              <a:buNone/>
              <a:defRPr sz="1500"/>
            </a:lvl7pPr>
            <a:lvl8pPr marL="5501168" indent="0">
              <a:buNone/>
              <a:defRPr sz="1500"/>
            </a:lvl8pPr>
            <a:lvl9pPr marL="6287049" indent="0">
              <a:buNone/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90" y="519084"/>
            <a:ext cx="8231029" cy="2160323"/>
          </a:xfrm>
          <a:prstGeom prst="rect">
            <a:avLst/>
          </a:prstGeom>
        </p:spPr>
        <p:txBody>
          <a:bodyPr vert="horz" lIns="157176" tIns="78588" rIns="157176" bIns="78588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90" y="3024459"/>
            <a:ext cx="8231029" cy="8554281"/>
          </a:xfrm>
          <a:prstGeom prst="rect">
            <a:avLst/>
          </a:prstGeom>
        </p:spPr>
        <p:txBody>
          <a:bodyPr vert="horz" lIns="157176" tIns="78588" rIns="157176" bIns="78588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80" y="12013804"/>
            <a:ext cx="2133971" cy="690104"/>
          </a:xfrm>
          <a:prstGeom prst="rect">
            <a:avLst/>
          </a:prstGeom>
        </p:spPr>
        <p:txBody>
          <a:bodyPr vert="horz" lIns="157176" tIns="78588" rIns="157176" bIns="78588" rtlCol="0" anchor="ctr"/>
          <a:lstStyle>
            <a:lvl1pPr algn="l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4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753" y="12013804"/>
            <a:ext cx="2896103" cy="690104"/>
          </a:xfrm>
          <a:prstGeom prst="rect">
            <a:avLst/>
          </a:prstGeom>
        </p:spPr>
        <p:txBody>
          <a:bodyPr vert="horz" lIns="157176" tIns="78588" rIns="157176" bIns="78588" rtlCol="0" anchor="ctr"/>
          <a:lstStyle>
            <a:lvl1pPr algn="ctr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4348" y="12013804"/>
            <a:ext cx="2133971" cy="690104"/>
          </a:xfrm>
          <a:prstGeom prst="rect">
            <a:avLst/>
          </a:prstGeom>
        </p:spPr>
        <p:txBody>
          <a:bodyPr vert="horz" lIns="157176" tIns="78588" rIns="157176" bIns="78588" rtlCol="0" anchor="ctr"/>
          <a:lstStyle>
            <a:lvl1pPr algn="r">
              <a:defRPr sz="2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71762" rtl="0" eaLnBrk="1" latinLnBrk="0" hangingPunct="1">
        <a:spcBef>
          <a:spcPct val="0"/>
        </a:spcBef>
        <a:buNone/>
        <a:defRPr sz="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89411" indent="-589411" algn="l" defTabSz="1571762" rtl="0" eaLnBrk="1" latinLnBrk="0" hangingPunct="1">
        <a:spcBef>
          <a:spcPct val="20000"/>
        </a:spcBef>
        <a:buFont typeface="Arial" pitchFamily="34" charset="0"/>
        <a:buChar char="•"/>
        <a:defRPr sz="5500" kern="1200">
          <a:solidFill>
            <a:schemeClr val="tx1"/>
          </a:solidFill>
          <a:latin typeface="+mn-lt"/>
          <a:ea typeface="+mn-ea"/>
          <a:cs typeface="+mn-cs"/>
        </a:defRPr>
      </a:lvl1pPr>
      <a:lvl2pPr marL="1277057" indent="-491176" algn="l" defTabSz="1571762" rtl="0" eaLnBrk="1" latinLnBrk="0" hangingPunct="1">
        <a:spcBef>
          <a:spcPct val="20000"/>
        </a:spcBef>
        <a:buFont typeface="Arial" pitchFamily="34" charset="0"/>
        <a:buChar char="–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1964703" indent="-392941" algn="l" defTabSz="1571762" rtl="0" eaLnBrk="1" latinLnBrk="0" hangingPunct="1">
        <a:spcBef>
          <a:spcPct val="20000"/>
        </a:spcBef>
        <a:buFont typeface="Arial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2750584" indent="-392941" algn="l" defTabSz="1571762" rtl="0" eaLnBrk="1" latinLnBrk="0" hangingPunct="1">
        <a:spcBef>
          <a:spcPct val="20000"/>
        </a:spcBef>
        <a:buFont typeface="Arial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536465" indent="-392941" algn="l" defTabSz="1571762" rtl="0" eaLnBrk="1" latinLnBrk="0" hangingPunct="1">
        <a:spcBef>
          <a:spcPct val="20000"/>
        </a:spcBef>
        <a:buFont typeface="Arial" pitchFamily="34" charset="0"/>
        <a:buChar char="»"/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322346" indent="-392941" algn="l" defTabSz="1571762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108227" indent="-392941" algn="l" defTabSz="1571762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5894108" indent="-392941" algn="l" defTabSz="1571762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679989" indent="-392941" algn="l" defTabSz="1571762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85881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571762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3pPr>
      <a:lvl4pPr marL="2357643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43524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929405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715286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501168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6287049" algn="l" defTabSz="1571762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812798" cy="435710"/>
          </a:xfrm>
          <a:prstGeom prst="rect">
            <a:avLst/>
          </a:prstGeom>
          <a:noFill/>
        </p:spPr>
        <p:txBody>
          <a:bodyPr wrap="square" lIns="157176" tIns="78588" rIns="157176" bIns="78588" rtlCol="0">
            <a:spAutoFit/>
          </a:bodyPr>
          <a:lstStyle/>
          <a:p>
            <a:r>
              <a:rPr lang="en-US" altLang="zh-CN" sz="180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表格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7804147"/>
              </p:ext>
            </p:extLst>
          </p:nvPr>
        </p:nvGraphicFramePr>
        <p:xfrm>
          <a:off x="396330" y="432297"/>
          <a:ext cx="8352928" cy="11312868"/>
        </p:xfrm>
        <a:graphic>
          <a:graphicData uri="http://schemas.openxmlformats.org/drawingml/2006/table">
            <a:tbl>
              <a:tblPr/>
              <a:tblGrid>
                <a:gridCol w="577342"/>
                <a:gridCol w="1582898"/>
                <a:gridCol w="1944216"/>
                <a:gridCol w="2016224"/>
                <a:gridCol w="576064"/>
                <a:gridCol w="720080"/>
                <a:gridCol w="936104"/>
              </a:tblGrid>
              <a:tr h="88523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2</a:t>
                      </a: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g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f-target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zh-CN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IOT)</a:t>
                      </a: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romosomal location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or intergenic region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quence (5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’ to 3’) </a:t>
                      </a:r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mismatch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: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d)</a:t>
                      </a:r>
                      <a:endParaRPr lang="zh-CN" altLang="zh-CN" sz="1050" b="1" i="0" u="none" strike="noStrike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ch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/</a:t>
                      </a:r>
                    </a:p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verall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mplicon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ze (bp)</a:t>
                      </a:r>
                      <a:endParaRPr lang="zh-CN" altLang="zh-CN" sz="1050" b="1" i="0" u="none" strike="noStrike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cted </a:t>
                      </a:r>
                      <a:endParaRPr lang="en-US" sz="105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ctr" fontAlgn="ctr"/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7EI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zh-CN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ragments (bp)</a:t>
                      </a:r>
                    </a:p>
                    <a:p>
                      <a:pPr algn="ctr" fontAlgn="ctr"/>
                      <a:r>
                        <a:rPr lang="zh-C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2</a:t>
                      </a:r>
                      <a:r>
                        <a:rPr lang="en-US" altLang="zh-CN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g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64197-8164219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2rg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GCCACCCGATCCACTGGGGG</a:t>
                      </a:r>
                      <a:endParaRPr lang="zh-CN" sz="105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1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600212-85600233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spholipase C-like 1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AC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TCCACTGGGGG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3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/321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75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2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placed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5555-505577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/microtubule affinity-regulating kinase 2-like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 dirty="0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CCACCC</a:t>
                      </a:r>
                      <a:r>
                        <a:rPr lang="en-US" sz="1050" b="0" i="0" u="none" strike="noStrike" dirty="0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 dirty="0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ACTGGGGG</a:t>
                      </a:r>
                      <a:endParaRPr lang="zh-CN" sz="105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2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/307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3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39169-8239191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genic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AC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TCCACTGGGGG</a:t>
                      </a:r>
                      <a:endParaRPr lang="zh-CN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3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/157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4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61305-15461327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genic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C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A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ATCCACTGGGGG</a:t>
                      </a:r>
                      <a:endParaRPr lang="zh-CN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3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1/272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02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5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placed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146-407168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genic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CCA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A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ACTGGGGG</a:t>
                      </a:r>
                      <a:endParaRPr lang="zh-CN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7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5/422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75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6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106943-28106965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mate receptor,ionotropic, AMPA2-like isoform 2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CTC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ACCC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CCACTGGGGG</a:t>
                      </a:r>
                      <a:endParaRPr lang="zh-CN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8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1/337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7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56258-1305628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minin 2 isoform 2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T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AC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TCCACTGGTGG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6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/249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8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466361-43466383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genic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CTT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A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ATCCACTGGTGG</a:t>
                      </a:r>
                      <a:endParaRPr lang="zh-CN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3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/234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OT9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16948-1441697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genic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AGC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ACCCGAT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ACTGGTGG</a:t>
                      </a:r>
                      <a:endParaRPr lang="zh-CN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4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5/299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935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G1 off-target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r>
                        <a:rPr lang="zh-CN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)</a:t>
                      </a: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romosomal location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or intergenic region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quence (5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’ to 3’) </a:t>
                      </a:r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mismatch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: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d</a:t>
                      </a:r>
                      <a:r>
                        <a:rPr lang="zh-CN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)</a:t>
                      </a: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ch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/</a:t>
                      </a:r>
                    </a:p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verall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mplicon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ze (bp)</a:t>
                      </a:r>
                      <a:endParaRPr lang="zh-CN" altLang="zh-CN" sz="1050" b="1" i="0" u="none" strike="noStrike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cted </a:t>
                      </a:r>
                      <a:endParaRPr lang="en-US" sz="105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ctr" fontAlgn="ctr"/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7EI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zh-CN" sz="105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ragments (bp)</a:t>
                      </a:r>
                    </a:p>
                    <a:p>
                      <a:pPr algn="ctr" fontAlgn="ctr"/>
                      <a:r>
                        <a:rPr lang="zh-CN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G1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96367-18196389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G1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TGGACCTTGAATGCTGGTGG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T1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 60405145-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405167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genic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TG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AATGCTGGTGG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4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/218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T2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910714-29910736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genic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TGGACCTT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T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8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/249</a:t>
                      </a:r>
                      <a:endParaRPr lang="zh-CN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T3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: </a:t>
                      </a:r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530288-4253031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genic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chemeClr val="tx1"/>
                          </a:solidFill>
                          <a:effectLst/>
                          <a:latin typeface="Courier New"/>
                        </a:rPr>
                        <a:t>GGGTGGACCTTGA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TGGTGG</a:t>
                      </a:r>
                      <a:endParaRPr lang="zh-CN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/20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5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/328</a:t>
                      </a:r>
                      <a:endParaRPr lang="zh-CN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935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KI1 off-target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r>
                        <a:rPr lang="zh-CN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)</a:t>
                      </a: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romosomal location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or intergenic region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quence (5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’ to 3’) </a:t>
                      </a:r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mismatch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: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d</a:t>
                      </a:r>
                      <a:r>
                        <a:rPr lang="zh-CN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)</a:t>
                      </a: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ch</a:t>
                      </a:r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/</a:t>
                      </a:r>
                    </a:p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verall</a:t>
                      </a:r>
                      <a:endParaRPr lang="zh-CN" sz="105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mplicon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ze (bp)</a:t>
                      </a:r>
                      <a:endParaRPr lang="zh-CN" altLang="zh-CN" sz="1050" b="1" i="0" u="none" strike="noStrike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cted </a:t>
                      </a:r>
                      <a:endParaRPr lang="en-US" sz="1050" b="1" i="0" u="none" strike="noStrike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ctr" fontAlgn="ctr"/>
                      <a:r>
                        <a:rPr lang="en-US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7EI</a:t>
                      </a:r>
                    </a:p>
                    <a:p>
                      <a:pPr marL="0" marR="0" indent="0" algn="ctr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zh-CN" sz="1050" b="1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ragments (bp)</a:t>
                      </a:r>
                    </a:p>
                    <a:p>
                      <a:pPr algn="ctr" fontAlgn="ctr"/>
                      <a:r>
                        <a:rPr lang="zh-CN" sz="105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7212" marR="7212" marT="57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24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KI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: 101312578 - 10131260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IKI1</a:t>
                      </a:r>
                      <a:endParaRPr lang="en-US" sz="1050" b="0" i="0" u="none" strike="noStrike" kern="12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CGCTGTCCCGCGGCGCGAGG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24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: 147542127 - 14754214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TGTC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CGCGAGG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/15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: 9230543 - 9230565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ropomyosin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CGCTGT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CGCGG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/292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24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placed: 731101 - 731123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igand of numb-protein X 1-like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TGTCCCGCGG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CGG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1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9/121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24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: 87421733 - 87421755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ranscription </a:t>
                      </a:r>
                      <a:r>
                        <a:rPr lang="en-US" sz="105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longation </a:t>
                      </a:r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actor </a:t>
                      </a:r>
                      <a:r>
                        <a:rPr lang="en-US" sz="105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 (SⅡ)-</a:t>
                      </a:r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ike 3-like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CT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GCGCGGGG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1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/261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24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: 38922277 -  3892229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CT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GCGCGC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5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6/21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: 12237206 - 12237228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TGTC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CGCGGGG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/278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: 12164579 - 12164601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TGTC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CGCGGGG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7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/322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:165018731-165018753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CT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C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CGCGA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7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/22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9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: 11733256-11733308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CT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CGC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CGCGG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4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9/155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: 93129554 - 93129576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C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CTGTCCCGC</a:t>
                      </a:r>
                      <a:r>
                        <a:rPr lang="en-US" sz="1050" b="0" i="0" u="none" strike="noStrike" dirty="0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C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CGCGG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7/251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24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placed : 4678991 - 4679013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  <a:endParaRPr lang="en-US" sz="105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CTGTCCC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G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/267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24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: 85100447-8510047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mber of RAS oncogene family like-4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CTGT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A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4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/27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: 87460924 - 87460946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CTGTCCC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5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8/267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41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: 37589871- 37587893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olypeptide N-acetygalactosaminytransferase </a:t>
                      </a:r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CTGT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GC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9/24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24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: 157670770 -157670792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C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CT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GCGCGG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7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/185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: 64159780-64159802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CC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CTGTCCC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GCGC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3/179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35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1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: 90534076-90534098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1571762" rtl="0" eaLnBrk="1" fontAlgn="ctr" latinLnBrk="0" hangingPunct="1"/>
                      <a:r>
                        <a:rPr lang="en-US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ergenic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AA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C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TGTCCCGCGGCG</a:t>
                      </a:r>
                      <a:r>
                        <a:rPr lang="en-US" sz="1050" b="0" i="0" u="none" strike="noStrike">
                          <a:solidFill>
                            <a:srgbClr val="FF0000"/>
                          </a:solidFill>
                          <a:effectLst/>
                          <a:latin typeface="Courier New"/>
                        </a:rPr>
                        <a:t>G</a:t>
                      </a:r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G</a:t>
                      </a:r>
                      <a:endParaRPr lang="en-US" sz="1050" b="0" i="0" u="none" strike="noStrike">
                        <a:solidFill>
                          <a:srgbClr val="FF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/20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/285</a:t>
                      </a:r>
                    </a:p>
                  </a:txBody>
                  <a:tcPr marL="9525" marR="9525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37686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2</TotalTime>
  <Words>457</Words>
  <Application>Microsoft Office PowerPoint</Application>
  <PresentationFormat>自定义</PresentationFormat>
  <Paragraphs>26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quanmei</dc:creator>
  <cp:lastModifiedBy>Yanquanmei</cp:lastModifiedBy>
  <cp:revision>91</cp:revision>
  <dcterms:created xsi:type="dcterms:W3CDTF">2013-11-20T13:12:58Z</dcterms:created>
  <dcterms:modified xsi:type="dcterms:W3CDTF">2014-07-01T07:50:50Z</dcterms:modified>
</cp:coreProperties>
</file>